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51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0E199-AA35-470B-B5DD-6084AF8B9BCE}" type="datetimeFigureOut">
              <a:rPr lang="en-GB" smtClean="0"/>
              <a:t>25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885B-74D7-4DDF-9C69-C0553A8671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089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0E199-AA35-470B-B5DD-6084AF8B9BCE}" type="datetimeFigureOut">
              <a:rPr lang="en-GB" smtClean="0"/>
              <a:t>25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885B-74D7-4DDF-9C69-C0553A8671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3925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0E199-AA35-470B-B5DD-6084AF8B9BCE}" type="datetimeFigureOut">
              <a:rPr lang="en-GB" smtClean="0"/>
              <a:t>25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885B-74D7-4DDF-9C69-C0553A8671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7283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0E199-AA35-470B-B5DD-6084AF8B9BCE}" type="datetimeFigureOut">
              <a:rPr lang="en-GB" smtClean="0"/>
              <a:t>25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885B-74D7-4DDF-9C69-C0553A8671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8975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0E199-AA35-470B-B5DD-6084AF8B9BCE}" type="datetimeFigureOut">
              <a:rPr lang="en-GB" smtClean="0"/>
              <a:t>25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885B-74D7-4DDF-9C69-C0553A8671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092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0E199-AA35-470B-B5DD-6084AF8B9BCE}" type="datetimeFigureOut">
              <a:rPr lang="en-GB" smtClean="0"/>
              <a:t>25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885B-74D7-4DDF-9C69-C0553A8671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098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0E199-AA35-470B-B5DD-6084AF8B9BCE}" type="datetimeFigureOut">
              <a:rPr lang="en-GB" smtClean="0"/>
              <a:t>25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885B-74D7-4DDF-9C69-C0553A8671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8325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0E199-AA35-470B-B5DD-6084AF8B9BCE}" type="datetimeFigureOut">
              <a:rPr lang="en-GB" smtClean="0"/>
              <a:t>25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885B-74D7-4DDF-9C69-C0553A8671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9862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0E199-AA35-470B-B5DD-6084AF8B9BCE}" type="datetimeFigureOut">
              <a:rPr lang="en-GB" smtClean="0"/>
              <a:t>25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885B-74D7-4DDF-9C69-C0553A8671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0457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0E199-AA35-470B-B5DD-6084AF8B9BCE}" type="datetimeFigureOut">
              <a:rPr lang="en-GB" smtClean="0"/>
              <a:t>25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885B-74D7-4DDF-9C69-C0553A8671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681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0E199-AA35-470B-B5DD-6084AF8B9BCE}" type="datetimeFigureOut">
              <a:rPr lang="en-GB" smtClean="0"/>
              <a:t>25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885B-74D7-4DDF-9C69-C0553A8671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9513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00E199-AA35-470B-B5DD-6084AF8B9BCE}" type="datetimeFigureOut">
              <a:rPr lang="en-GB" smtClean="0"/>
              <a:t>25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F885B-74D7-4DDF-9C69-C0553A86716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8427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a 1">
            <a:extLst>
              <a:ext uri="{FF2B5EF4-FFF2-40B4-BE49-F238E27FC236}">
                <a16:creationId xmlns:a16="http://schemas.microsoft.com/office/drawing/2014/main" id="{B4258421-D1BB-4AA4-B12B-78C54DD092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4103751"/>
              </p:ext>
            </p:extLst>
          </p:nvPr>
        </p:nvGraphicFramePr>
        <p:xfrm>
          <a:off x="923025" y="818609"/>
          <a:ext cx="7194431" cy="494383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69110">
                  <a:extLst>
                    <a:ext uri="{9D8B030D-6E8A-4147-A177-3AD203B41FA5}">
                      <a16:colId xmlns:a16="http://schemas.microsoft.com/office/drawing/2014/main" val="1564587707"/>
                    </a:ext>
                  </a:extLst>
                </a:gridCol>
                <a:gridCol w="1827484">
                  <a:extLst>
                    <a:ext uri="{9D8B030D-6E8A-4147-A177-3AD203B41FA5}">
                      <a16:colId xmlns:a16="http://schemas.microsoft.com/office/drawing/2014/main" val="2375315994"/>
                    </a:ext>
                  </a:extLst>
                </a:gridCol>
                <a:gridCol w="1740135">
                  <a:extLst>
                    <a:ext uri="{9D8B030D-6E8A-4147-A177-3AD203B41FA5}">
                      <a16:colId xmlns:a16="http://schemas.microsoft.com/office/drawing/2014/main" val="2008336247"/>
                    </a:ext>
                  </a:extLst>
                </a:gridCol>
                <a:gridCol w="1557702">
                  <a:extLst>
                    <a:ext uri="{9D8B030D-6E8A-4147-A177-3AD203B41FA5}">
                      <a16:colId xmlns:a16="http://schemas.microsoft.com/office/drawing/2014/main" val="3109465758"/>
                    </a:ext>
                  </a:extLst>
                </a:gridCol>
              </a:tblGrid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Antibody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Sourc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Clon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Dilution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32036025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Smooth muscle acti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DA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A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eady to u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95835124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Myosi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DAKO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SMMS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eady to u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03423906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Smootheli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Biocare medical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4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/10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89840494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H-Caldesmo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DAKO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H-CD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eady to u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89476589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Desmi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DA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D3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eady to u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53333485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Cyclin D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DA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EP1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eady to u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44782565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CD1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DA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DAK-CD1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eady to u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66468804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CD3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DA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QBend1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eady to u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32784735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BCO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Santa Cruz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CI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/5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40496851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TLE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Gennov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F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/20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95400656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SS18-SXX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BioSB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BT-SS18-SSX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/5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8535737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TRSP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BioSB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EP39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/50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69714629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EM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DA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IR629 (E29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prediluited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71830055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Progesterone recepto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DA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PgR129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eady to u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98688009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Estrogen recepto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DA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Clon EP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eady to u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5302358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ALK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DA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 OTI1a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ready to u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20777975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panTRK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Gennov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EPR1734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/2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78343592"/>
                  </a:ext>
                </a:extLst>
              </a:tr>
              <a:tr h="260202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S10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DAKO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Policlonal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ready to us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8340872"/>
                  </a:ext>
                </a:extLst>
              </a:tr>
            </a:tbl>
          </a:graphicData>
        </a:graphic>
      </p:graphicFrame>
      <p:sp>
        <p:nvSpPr>
          <p:cNvPr id="3" name="Rectángulo 2">
            <a:extLst>
              <a:ext uri="{FF2B5EF4-FFF2-40B4-BE49-F238E27FC236}">
                <a16:creationId xmlns:a16="http://schemas.microsoft.com/office/drawing/2014/main" id="{3DF89004-7813-4F3E-BE1F-B256ABF55A12}"/>
              </a:ext>
            </a:extLst>
          </p:cNvPr>
          <p:cNvSpPr/>
          <p:nvPr/>
        </p:nvSpPr>
        <p:spPr>
          <a:xfrm>
            <a:off x="1620318" y="299198"/>
            <a:ext cx="669194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>
                <a:latin typeface="Arial" panose="020B0604020202020204" pitchFamily="34" charset="0"/>
                <a:ea typeface="Aptos"/>
              </a:rPr>
              <a:t> </a:t>
            </a:r>
            <a:r>
              <a:rPr lang="en-GB" sz="1400" dirty="0">
                <a:latin typeface="Arial" panose="020B0604020202020204" pitchFamily="34" charset="0"/>
                <a:ea typeface="Aptos"/>
              </a:rPr>
              <a:t>Table 1. Immunohistochemical stains (sources, clones, and dilutions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060954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4</Words>
  <Application>Microsoft Office PowerPoint</Application>
  <PresentationFormat>Presentación en pantalla (4:3)</PresentationFormat>
  <Paragraphs>7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sidro Machado Puerto</dc:creator>
  <cp:lastModifiedBy>Isidro Machado Puerto</cp:lastModifiedBy>
  <cp:revision>2</cp:revision>
  <dcterms:created xsi:type="dcterms:W3CDTF">2025-07-25T09:23:58Z</dcterms:created>
  <dcterms:modified xsi:type="dcterms:W3CDTF">2025-07-25T09:24:46Z</dcterms:modified>
</cp:coreProperties>
</file>